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0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BDDEC-5D16-4F1D-BE1F-06911E58C830}" type="datetimeFigureOut">
              <a:rPr lang="ko-KR" altLang="en-US" smtClean="0"/>
              <a:pPr/>
              <a:t>2012-11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8FD68-531D-4D39-AF11-9603AF895FB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직선 화살표 연결선 9"/>
          <p:cNvCxnSpPr/>
          <p:nvPr/>
        </p:nvCxnSpPr>
        <p:spPr>
          <a:xfrm>
            <a:off x="5292080" y="5085184"/>
            <a:ext cx="360040" cy="1588"/>
          </a:xfrm>
          <a:prstGeom prst="straightConnector1">
            <a:avLst/>
          </a:prstGeom>
          <a:ln w="28575">
            <a:solidFill>
              <a:schemeClr val="bg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0" y="0"/>
            <a:ext cx="6984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Fig S1</a:t>
            </a:r>
            <a:endParaRPr lang="ko-KR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31640" y="306896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*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grpSp>
        <p:nvGrpSpPr>
          <p:cNvPr id="8" name="그룹 42"/>
          <p:cNvGrpSpPr/>
          <p:nvPr/>
        </p:nvGrpSpPr>
        <p:grpSpPr>
          <a:xfrm>
            <a:off x="2051720" y="1412776"/>
            <a:ext cx="4367348" cy="2929844"/>
            <a:chOff x="2627784" y="944724"/>
            <a:chExt cx="4367348" cy="2929844"/>
          </a:xfrm>
        </p:grpSpPr>
        <p:sp>
          <p:nvSpPr>
            <p:cNvPr id="3" name="TextBox 2"/>
            <p:cNvSpPr txBox="1"/>
            <p:nvPr/>
          </p:nvSpPr>
          <p:spPr>
            <a:xfrm>
              <a:off x="3059832" y="1124744"/>
              <a:ext cx="18659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err="1" smtClean="0">
                  <a:latin typeface="Tahoma" pitchFamily="34" charset="0"/>
                  <a:cs typeface="Tahoma" pitchFamily="34" charset="0"/>
                </a:rPr>
                <a:t>pET-opTAL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365050" y="1412776"/>
              <a:ext cx="12231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M    3      4  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364088" y="1124744"/>
              <a:ext cx="14022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err="1" smtClean="0">
                  <a:latin typeface="Tahoma" pitchFamily="34" charset="0"/>
                  <a:cs typeface="Tahoma" pitchFamily="34" charset="0"/>
                </a:rPr>
                <a:t>pET</a:t>
              </a:r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-TAL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59832" y="1484784"/>
              <a:ext cx="12231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M     1      2  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grpSp>
          <p:nvGrpSpPr>
            <p:cNvPr id="9" name="그룹 29"/>
            <p:cNvGrpSpPr/>
            <p:nvPr/>
          </p:nvGrpSpPr>
          <p:grpSpPr>
            <a:xfrm>
              <a:off x="2627784" y="1484784"/>
              <a:ext cx="1559555" cy="2389784"/>
              <a:chOff x="2627784" y="1484784"/>
              <a:chExt cx="1559555" cy="2389784"/>
            </a:xfrm>
          </p:grpSpPr>
          <p:pic>
            <p:nvPicPr>
              <p:cNvPr id="2" name="Picture 2" descr="E:\2012.04\20120427 expression 데이터용사진\EPSN0001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grayscl/>
                <a:lum bright="40000" contrast="69000"/>
              </a:blip>
              <a:srcRect l="7382" t="16983" r="67463" b="47085"/>
              <a:stretch>
                <a:fillRect/>
              </a:stretch>
            </p:blipFill>
            <p:spPr bwMode="auto">
              <a:xfrm flipH="1">
                <a:off x="3100944" y="1772816"/>
                <a:ext cx="1086395" cy="2101752"/>
              </a:xfrm>
              <a:prstGeom prst="rect">
                <a:avLst/>
              </a:prstGeom>
              <a:noFill/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2675073" y="1772816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95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675073" y="2060848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72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675073" y="2492896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55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675073" y="2924944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43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675073" y="3573016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34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627784" y="1484784"/>
                <a:ext cx="4459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err="1" smtClean="0">
                    <a:latin typeface="Tahoma" pitchFamily="34" charset="0"/>
                    <a:cs typeface="Tahoma" pitchFamily="34" charset="0"/>
                  </a:rPr>
                  <a:t>kDa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</p:grpSp>
        <p:grpSp>
          <p:nvGrpSpPr>
            <p:cNvPr id="11" name="그룹 28"/>
            <p:cNvGrpSpPr/>
            <p:nvPr/>
          </p:nvGrpSpPr>
          <p:grpSpPr>
            <a:xfrm>
              <a:off x="4932040" y="1423809"/>
              <a:ext cx="1571832" cy="2437239"/>
              <a:chOff x="4932040" y="1423809"/>
              <a:chExt cx="1571832" cy="2437239"/>
            </a:xfrm>
          </p:grpSpPr>
          <p:pic>
            <p:nvPicPr>
              <p:cNvPr id="4" name="Picture 2" descr="C:\Documents and Settings\Administrator\바탕 화면\졸업논문-강선영\한국미생물학회\SDS page gel 데이터사진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5110" t="40649" r="84069" b="6574"/>
              <a:stretch>
                <a:fillRect/>
              </a:stretch>
            </p:blipFill>
            <p:spPr bwMode="auto">
              <a:xfrm flipH="1">
                <a:off x="5292080" y="1700808"/>
                <a:ext cx="1211792" cy="2088232"/>
              </a:xfrm>
              <a:prstGeom prst="rect">
                <a:avLst/>
              </a:prstGeom>
              <a:noFill/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4979329" y="1711841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95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979329" y="1916832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72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979329" y="2431921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55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979329" y="2852936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43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979329" y="3584049"/>
                <a:ext cx="3513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ahoma" pitchFamily="34" charset="0"/>
                    <a:cs typeface="Tahoma" pitchFamily="34" charset="0"/>
                  </a:rPr>
                  <a:t>34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932040" y="1423809"/>
                <a:ext cx="4459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err="1" smtClean="0">
                    <a:latin typeface="Tahoma" pitchFamily="34" charset="0"/>
                    <a:cs typeface="Tahoma" pitchFamily="34" charset="0"/>
                  </a:rPr>
                  <a:t>kDa</a:t>
                </a:r>
                <a:endParaRPr lang="ko-KR" altLang="en-US" sz="1200" dirty="0">
                  <a:latin typeface="Tahoma" pitchFamily="34" charset="0"/>
                  <a:cs typeface="Tahoma" pitchFamily="34" charset="0"/>
                </a:endParaRPr>
              </a:p>
            </p:txBody>
          </p:sp>
        </p:grpSp>
        <p:cxnSp>
          <p:nvCxnSpPr>
            <p:cNvPr id="32" name="직선 화살표 연결선 31"/>
            <p:cNvCxnSpPr/>
            <p:nvPr/>
          </p:nvCxnSpPr>
          <p:spPr>
            <a:xfrm flipV="1">
              <a:off x="3809148" y="2595273"/>
              <a:ext cx="504056" cy="9382"/>
            </a:xfrm>
            <a:prstGeom prst="straightConnector1">
              <a:avLst/>
            </a:prstGeom>
            <a:ln w="28575">
              <a:solidFill>
                <a:schemeClr val="bg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화살표 연결선 32"/>
            <p:cNvCxnSpPr/>
            <p:nvPr/>
          </p:nvCxnSpPr>
          <p:spPr>
            <a:xfrm flipV="1">
              <a:off x="6064920" y="2595418"/>
              <a:ext cx="548316" cy="1953"/>
            </a:xfrm>
            <a:prstGeom prst="straightConnector1">
              <a:avLst/>
            </a:prstGeom>
            <a:ln w="28575">
              <a:solidFill>
                <a:schemeClr val="bg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4309794" y="2472858"/>
              <a:ext cx="673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err="1" smtClean="0">
                  <a:latin typeface="Tahoma" pitchFamily="34" charset="0"/>
                  <a:cs typeface="Tahoma" pitchFamily="34" charset="0"/>
                </a:rPr>
                <a:t>opTAL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519168" y="2436695"/>
              <a:ext cx="475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TAL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627784" y="944724"/>
              <a:ext cx="407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A)</a:t>
              </a:r>
              <a:endParaRPr lang="ko-KR" altLang="en-US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932040" y="94472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B)</a:t>
              </a:r>
              <a:endParaRPr lang="ko-KR" altLang="en-US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0" y="0"/>
            <a:ext cx="6984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Fig S2</a:t>
            </a:r>
            <a:endParaRPr lang="ko-KR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그룹 56"/>
          <p:cNvGrpSpPr/>
          <p:nvPr/>
        </p:nvGrpSpPr>
        <p:grpSpPr>
          <a:xfrm>
            <a:off x="1749780" y="1412776"/>
            <a:ext cx="2894912" cy="3163223"/>
            <a:chOff x="669660" y="1340768"/>
            <a:chExt cx="2894912" cy="3163223"/>
          </a:xfrm>
        </p:grpSpPr>
        <p:pic>
          <p:nvPicPr>
            <p:cNvPr id="5" name="Picture 3" descr="E:\2012.04\20120427 expression 데이터용사진\EPSN0002.JPG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  <a:lum bright="30000" contrast="60000"/>
            </a:blip>
            <a:srcRect l="29244" t="19744" r="46117" b="41681"/>
            <a:stretch>
              <a:fillRect/>
            </a:stretch>
          </p:blipFill>
          <p:spPr bwMode="auto">
            <a:xfrm>
              <a:off x="1115616" y="2271742"/>
              <a:ext cx="864096" cy="2232249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1043608" y="1628800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pET-opT5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043608" y="1988840"/>
              <a:ext cx="12231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M    1    2  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16949" y="2348880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95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16949" y="2636912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72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16949" y="3068960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55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16949" y="3501008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43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16949" y="4149080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34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69660" y="2132856"/>
              <a:ext cx="4459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ahoma" pitchFamily="34" charset="0"/>
                  <a:cs typeface="Tahoma" pitchFamily="34" charset="0"/>
                </a:rPr>
                <a:t>kDa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83568" y="1340768"/>
              <a:ext cx="407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A)</a:t>
              </a:r>
              <a:endParaRPr lang="ko-KR" altLang="en-US" dirty="0"/>
            </a:p>
          </p:txBody>
        </p:sp>
        <p:cxnSp>
          <p:nvCxnSpPr>
            <p:cNvPr id="45" name="직선 화살표 연결선 44"/>
            <p:cNvCxnSpPr/>
            <p:nvPr/>
          </p:nvCxnSpPr>
          <p:spPr>
            <a:xfrm>
              <a:off x="1907704" y="3140968"/>
              <a:ext cx="36004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2195736" y="2977697"/>
              <a:ext cx="13227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Sam5 (59kDa)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cxnSp>
          <p:nvCxnSpPr>
            <p:cNvPr id="47" name="직선 화살표 연결선 46"/>
            <p:cNvCxnSpPr/>
            <p:nvPr/>
          </p:nvCxnSpPr>
          <p:spPr>
            <a:xfrm>
              <a:off x="1933313" y="3250348"/>
              <a:ext cx="36004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2195736" y="3130097"/>
              <a:ext cx="13688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err="1" smtClean="0">
                  <a:latin typeface="Tahoma" pitchFamily="34" charset="0"/>
                  <a:cs typeface="Tahoma" pitchFamily="34" charset="0"/>
                </a:rPr>
                <a:t>opTAL</a:t>
              </a:r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 (56kDa)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</p:grpSp>
      <p:grpSp>
        <p:nvGrpSpPr>
          <p:cNvPr id="8" name="그룹 55"/>
          <p:cNvGrpSpPr/>
          <p:nvPr/>
        </p:nvGrpSpPr>
        <p:grpSpPr>
          <a:xfrm>
            <a:off x="4897446" y="1412776"/>
            <a:ext cx="3117283" cy="3169492"/>
            <a:chOff x="3347864" y="1340768"/>
            <a:chExt cx="3117283" cy="3169492"/>
          </a:xfrm>
        </p:grpSpPr>
        <p:pic>
          <p:nvPicPr>
            <p:cNvPr id="2" name="Picture 2" descr="E:\2012.04\20120427 expression 데이터용사진\EPSN0001.JPG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lum bright="40000" contrast="69000"/>
            </a:blip>
            <a:srcRect l="25350" t="15783" r="51291" b="47085"/>
            <a:stretch>
              <a:fillRect/>
            </a:stretch>
          </p:blipFill>
          <p:spPr bwMode="auto">
            <a:xfrm>
              <a:off x="3786187" y="2256352"/>
              <a:ext cx="900506" cy="2253908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3691760" y="1948575"/>
              <a:ext cx="16786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M    3     4    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835776" y="1629940"/>
              <a:ext cx="16786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pET-T5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419872" y="2348880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95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419872" y="2625879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72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19872" y="3079993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55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419872" y="3561983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43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419872" y="4221088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ahoma" pitchFamily="34" charset="0"/>
                  <a:cs typeface="Tahoma" pitchFamily="34" charset="0"/>
                </a:rPr>
                <a:t>34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372583" y="2132856"/>
              <a:ext cx="4459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ahoma" pitchFamily="34" charset="0"/>
                  <a:cs typeface="Tahoma" pitchFamily="34" charset="0"/>
                </a:rPr>
                <a:t>kDa</a:t>
              </a:r>
              <a:endParaRPr lang="ko-KR" altLang="en-US" sz="12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154339" y="2852936"/>
              <a:ext cx="12666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Sam5(59kDa)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347864" y="1340768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B)</a:t>
              </a:r>
              <a:endParaRPr lang="ko-KR" altLang="en-US" dirty="0"/>
            </a:p>
          </p:txBody>
        </p:sp>
        <p:grpSp>
          <p:nvGrpSpPr>
            <p:cNvPr id="9" name="그룹 53"/>
            <p:cNvGrpSpPr/>
            <p:nvPr/>
          </p:nvGrpSpPr>
          <p:grpSpPr>
            <a:xfrm>
              <a:off x="4650283" y="3068960"/>
              <a:ext cx="504056" cy="146325"/>
              <a:chOff x="4427984" y="3068960"/>
              <a:chExt cx="504056" cy="146325"/>
            </a:xfrm>
          </p:grpSpPr>
          <p:cxnSp>
            <p:nvCxnSpPr>
              <p:cNvPr id="25" name="직선 화살표 연결선 24"/>
              <p:cNvCxnSpPr/>
              <p:nvPr/>
            </p:nvCxnSpPr>
            <p:spPr>
              <a:xfrm>
                <a:off x="4427984" y="3140968"/>
                <a:ext cx="36004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arrow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꺾인 연결선 51"/>
              <p:cNvCxnSpPr/>
              <p:nvPr/>
            </p:nvCxnSpPr>
            <p:spPr>
              <a:xfrm flipV="1">
                <a:off x="4788024" y="3068960"/>
                <a:ext cx="144016" cy="72008"/>
              </a:xfrm>
              <a:prstGeom prst="bentConnector3">
                <a:avLst>
                  <a:gd name="adj1" fmla="val 5000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꺾인 연결선 52"/>
              <p:cNvCxnSpPr/>
              <p:nvPr/>
            </p:nvCxnSpPr>
            <p:spPr>
              <a:xfrm>
                <a:off x="4785467" y="3143277"/>
                <a:ext cx="144016" cy="72008"/>
              </a:xfrm>
              <a:prstGeom prst="bentConnector3">
                <a:avLst>
                  <a:gd name="adj1" fmla="val 5000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5154339" y="3068960"/>
              <a:ext cx="13108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Tahoma" pitchFamily="34" charset="0"/>
                  <a:cs typeface="Tahoma" pitchFamily="34" charset="0"/>
                </a:rPr>
                <a:t>TAL (57.4kDa)</a:t>
              </a:r>
              <a:endParaRPr lang="ko-KR" altLang="en-US" sz="1400" dirty="0">
                <a:latin typeface="Tahoma" pitchFamily="34" charset="0"/>
                <a:cs typeface="Tahoma" pitchFamily="3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kumimoji="1" lang="en-GB" altLang="ko-KR" sz="1200" b="1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Table </a:t>
            </a:r>
            <a:r>
              <a:rPr kumimoji="1" lang="en-GB" altLang="ko-KR" sz="1200" b="1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S1</a:t>
            </a:r>
            <a:r>
              <a:rPr lang="en-GB" altLang="ko-KR" dirty="0" smtClean="0"/>
              <a:t> </a:t>
            </a:r>
            <a:r>
              <a:rPr kumimoji="1" lang="en-GB" altLang="ko-KR" sz="1200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The results of the </a:t>
            </a:r>
            <a:r>
              <a:rPr kumimoji="1" lang="en-GB" altLang="ko-KR" sz="1200" dirty="0" err="1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Tukey</a:t>
            </a:r>
            <a:r>
              <a:rPr kumimoji="1" lang="en-GB" altLang="ko-KR" sz="1200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 test for the data from </a:t>
            </a:r>
            <a:r>
              <a:rPr kumimoji="1" lang="en-GB" altLang="ko-KR" sz="1200" dirty="0" err="1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Figu</a:t>
            </a:r>
            <a:r>
              <a:rPr kumimoji="1" lang="en-US" altLang="ko-KR" sz="1200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re </a:t>
            </a:r>
            <a:r>
              <a:rPr kumimoji="1" lang="en-GB" altLang="ko-KR" sz="1200" dirty="0" smtClean="0">
                <a:solidFill>
                  <a:srgbClr val="000000"/>
                </a:solidFill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3</a:t>
            </a:r>
            <a:endParaRPr kumimoji="1" lang="ko-KR" altLang="en-US" sz="1200" dirty="0" smtClean="0">
              <a:solidFill>
                <a:srgbClr val="000000"/>
              </a:solidFill>
              <a:latin typeface="Times New Roman" pitchFamily="18" charset="0"/>
              <a:ea typeface="바탕" pitchFamily="18" charset="-127"/>
              <a:cs typeface="Times New Roman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1259632" y="908720"/>
          <a:ext cx="6768754" cy="4441698"/>
        </p:xfrm>
        <a:graphic>
          <a:graphicData uri="http://schemas.openxmlformats.org/drawingml/2006/table">
            <a:tbl>
              <a:tblPr/>
              <a:tblGrid>
                <a:gridCol w="965842"/>
                <a:gridCol w="690342"/>
                <a:gridCol w="1343588"/>
                <a:gridCol w="1032676"/>
                <a:gridCol w="851815"/>
                <a:gridCol w="965842"/>
                <a:gridCol w="918649"/>
              </a:tblGrid>
              <a:tr h="325120">
                <a:tc gridSpan="7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Multiple Comparisons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Dependent Variable : productivity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162560">
                <a:tc gridSpan="7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Tukey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 HSD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325120"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(I)Strains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(J) Strains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Mean Difference(I-J)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Std. Error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Sig.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95% Confidence Interval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32512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Lower Bound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Upper Bound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25120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85.333333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26.3079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44.358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3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1.000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7.929492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65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29.1835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71.1835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2512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70.000000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10.97466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29.0253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85.333333</a:t>
                      </a:r>
                      <a:r>
                        <a:rPr lang="en-US" sz="1000" kern="100" baseline="300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4.358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26.3079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2512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06.333333</a:t>
                      </a:r>
                      <a:r>
                        <a:rPr lang="en-US" sz="1000" kern="100" baseline="300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65.358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7.3079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5.333333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0.35159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4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3.6401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4.3067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21.000000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7.929492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65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71.1835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9.1835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2512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06.333333</a:t>
                      </a:r>
                      <a:r>
                        <a:rPr lang="en-US" sz="1000" kern="100" baseline="300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47.3079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65.358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2512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91.000000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31.97466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50.0253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70.000000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1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9.0253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10.97466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2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15.33333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0.351597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467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-44.30679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3.6401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625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3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91.000000</a:t>
                      </a:r>
                      <a:r>
                        <a:rPr lang="en-US" sz="1000" kern="100" baseline="300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4.639369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.000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50.02534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131.97466</a:t>
                      </a:r>
                      <a:endParaRPr lang="ko-KR" sz="1000" kern="100">
                        <a:latin typeface="+mn-lt"/>
                        <a:ea typeface="맑은 고딕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2560">
                <a:tc gridSpan="7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latin typeface="+mn-lt"/>
                          <a:ea typeface="맑은 고딕"/>
                          <a:cs typeface="Gulim"/>
                        </a:rPr>
                        <a:t>*. This mean difference is significant at the 0.05 level.</a:t>
                      </a:r>
                      <a:endParaRPr lang="ko-KR" sz="1000" kern="100" dirty="0">
                        <a:latin typeface="+mn-lt"/>
                        <a:ea typeface="맑은 고딕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539552" y="1628800"/>
          <a:ext cx="8424936" cy="3286463"/>
        </p:xfrm>
        <a:graphic>
          <a:graphicData uri="http://schemas.openxmlformats.org/drawingml/2006/table">
            <a:tbl>
              <a:tblPr/>
              <a:tblGrid>
                <a:gridCol w="864096"/>
                <a:gridCol w="6048672"/>
                <a:gridCol w="1512168"/>
              </a:tblGrid>
              <a:tr h="270293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latin typeface="Tahoma"/>
                          <a:ea typeface="맑은 고딕"/>
                          <a:cs typeface="Times New Roman"/>
                        </a:rPr>
                        <a:t>Name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latin typeface="Tahoma"/>
                          <a:ea typeface="맑은 고딕"/>
                          <a:cs typeface="Times New Roman"/>
                        </a:rPr>
                        <a:t>Sequences (5’-3’)</a:t>
                      </a:r>
                      <a:endParaRPr lang="ko-KR" sz="10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latin typeface="Tahoma"/>
                          <a:ea typeface="맑은 고딕"/>
                          <a:cs typeface="Times New Roman"/>
                        </a:rPr>
                        <a:t>Restriction Enzyme site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tyr-Rf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GTCATATCATCATATTAATTGTTCTTTTTTCAGGTGAAGGTTCCCATGCGTAATTAACCCTCACTAAAGGGCG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ko-KR" sz="1000" kern="100" dirty="0">
                        <a:latin typeface="맑은 고딕"/>
                        <a:ea typeface="맑은 고딕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tyr-Rr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kern="0">
                          <a:latin typeface="Tahoma"/>
                          <a:ea typeface="맑은 고딕"/>
                          <a:cs typeface="Times New Roman"/>
                        </a:rPr>
                        <a:t>ATCAGGCATATTCGCGCTTACTCTTCGTTCTTCTTCTGACTCAGACCATATAATACGACTCACTATAGGGCTC</a:t>
                      </a:r>
                      <a:endParaRPr lang="ko-KR" sz="10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ko-KR" sz="1000" kern="100" dirty="0">
                        <a:latin typeface="맑은 고딕"/>
                        <a:ea typeface="맑은 고딕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tyr-v1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ACCTCGCCTCGGGGATTT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ko-KR" sz="1000" kern="100" dirty="0">
                        <a:latin typeface="맑은 고딕"/>
                        <a:ea typeface="맑은 고딕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tyr-v2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GCGCGTGCCGTTGTGGTTA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ko-KR" sz="1000" kern="100" dirty="0">
                        <a:latin typeface="맑은 고딕"/>
                        <a:ea typeface="맑은 고딕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opTAL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-F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CATATG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CCCAGGTGGTTGAACGCC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Nde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opTAL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-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AGCT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GCCAAAGTCTTTACCATCGGC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Hin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dII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TAL-N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GATC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CGCAGGTCGTGGAACGT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Bgl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I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TAL-C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AGCT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GTGTGCTCATCCGAAATCCTT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Hin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dII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Sam5-F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CATATG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CCATCACGTCACCTGCGCCGG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Nde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Sam5-R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AGCT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CAGGTGCCGGGGTTGATCAGGTCGG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Hin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dIII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COM-F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CATATG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GGTTCAACGGCAGAGAC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Nde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COM-R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AGCT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GAGCTTCTTGAGTAACTC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Hin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dIII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 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CPa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TTAATTAA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GCGCCGCTACAGGGCGCGTC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Pac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NPa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TTAATTAA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CGCCGCGACAATTTGCGACGG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Pac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82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Cspe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CTAG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TCCTCCTTTCAGCAAAAAACCCCT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Spe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4273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Nspe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spcAft>
                          <a:spcPts val="0"/>
                        </a:spcAft>
                      </a:pPr>
                      <a:r>
                        <a:rPr lang="en-US" sz="1000" u="sng" kern="0" dirty="0">
                          <a:latin typeface="Tahoma"/>
                          <a:ea typeface="맑은 고딕"/>
                          <a:cs typeface="Times New Roman"/>
                        </a:rPr>
                        <a:t>ACTAGT</a:t>
                      </a:r>
                      <a:r>
                        <a:rPr lang="en-US" sz="1000" kern="0" dirty="0">
                          <a:latin typeface="Tahoma"/>
                          <a:ea typeface="맑은 고딕"/>
                          <a:cs typeface="Times New Roman"/>
                        </a:rPr>
                        <a:t>AGGTTGAGGCCGTTGAGCACCGCC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latin typeface="Tahoma"/>
                          <a:ea typeface="맑은 고딕"/>
                          <a:cs typeface="Times New Roman"/>
                        </a:rPr>
                        <a:t>Spe</a:t>
                      </a:r>
                      <a:r>
                        <a:rPr lang="en-US" sz="1000" kern="0" dirty="0" err="1">
                          <a:latin typeface="Tahoma"/>
                          <a:ea typeface="맑은 고딕"/>
                          <a:cs typeface="Times New Roman"/>
                        </a:rPr>
                        <a:t>I</a:t>
                      </a:r>
                      <a:endParaRPr lang="ko-KR" sz="10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44837" marR="4483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-48399"/>
            <a:ext cx="3810595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29845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Table </a:t>
            </a: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S2.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 </a:t>
            </a:r>
            <a:r>
              <a:rPr kumimoji="1" lang="en-US" altLang="ko-KR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Oligo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 nucleotide primers used in this study.</a:t>
            </a:r>
            <a:endParaRPr kumimoji="1" lang="en-US" altLang="ko-KR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  <a:p>
            <a:pPr marL="0" marR="0" lvl="0" indent="298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04</Words>
  <Application>Microsoft Office PowerPoint</Application>
  <PresentationFormat>화면 슬라이드 쇼(4:3)</PresentationFormat>
  <Paragraphs>182</Paragraphs>
  <Slides>4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5" baseType="lpstr">
      <vt:lpstr>Office 테마</vt:lpstr>
      <vt:lpstr>슬라이드 1</vt:lpstr>
      <vt:lpstr>슬라이드 2</vt:lpstr>
      <vt:lpstr>슬라이드 3</vt:lpstr>
      <vt:lpstr>슬라이드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홍영수</dc:creator>
  <cp:lastModifiedBy>홍영수</cp:lastModifiedBy>
  <cp:revision>3</cp:revision>
  <dcterms:created xsi:type="dcterms:W3CDTF">2012-09-15T04:22:04Z</dcterms:created>
  <dcterms:modified xsi:type="dcterms:W3CDTF">2012-11-15T11:30:03Z</dcterms:modified>
</cp:coreProperties>
</file>